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281" r:id="rId2"/>
    <p:sldId id="278" r:id="rId3"/>
    <p:sldId id="279" r:id="rId4"/>
    <p:sldId id="280" r:id="rId5"/>
    <p:sldId id="282" r:id="rId6"/>
  </p:sldIdLst>
  <p:sldSz cx="6858000" cy="9144000" type="screen4x3"/>
  <p:notesSz cx="6858000" cy="9144000"/>
  <p:defaultTextStyle>
    <a:defPPr>
      <a:defRPr lang="ja-JP"/>
    </a:defPPr>
    <a:lvl1pPr algn="l" defTabSz="457200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-128"/>
        <a:cs typeface="ＭＳ Ｐゴシック" charset="-128"/>
      </a:defRPr>
    </a:lvl1pPr>
    <a:lvl2pPr marL="457200" algn="l" defTabSz="457200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-128"/>
        <a:cs typeface="ＭＳ Ｐゴシック" charset="-128"/>
      </a:defRPr>
    </a:lvl2pPr>
    <a:lvl3pPr marL="914400" algn="l" defTabSz="457200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-128"/>
        <a:cs typeface="ＭＳ Ｐゴシック" charset="-128"/>
      </a:defRPr>
    </a:lvl3pPr>
    <a:lvl4pPr marL="1371600" algn="l" defTabSz="457200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-128"/>
        <a:cs typeface="ＭＳ Ｐゴシック" charset="-128"/>
      </a:defRPr>
    </a:lvl4pPr>
    <a:lvl5pPr marL="1828800" algn="l" defTabSz="457200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-128"/>
        <a:cs typeface="ＭＳ Ｐゴシック" charset="-128"/>
      </a:defRPr>
    </a:lvl5pPr>
    <a:lvl6pPr marL="22860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-128"/>
        <a:cs typeface="ＭＳ Ｐゴシック" charset="-128"/>
      </a:defRPr>
    </a:lvl6pPr>
    <a:lvl7pPr marL="27432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-128"/>
        <a:cs typeface="ＭＳ Ｐゴシック" charset="-128"/>
      </a:defRPr>
    </a:lvl7pPr>
    <a:lvl8pPr marL="32004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-128"/>
        <a:cs typeface="ＭＳ Ｐゴシック" charset="-128"/>
      </a:defRPr>
    </a:lvl8pPr>
    <a:lvl9pPr marL="36576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-128"/>
        <a:cs typeface="ＭＳ Ｐゴシック" charset="-128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C00"/>
    <a:srgbClr val="FF2600"/>
    <a:srgbClr val="942092"/>
    <a:srgbClr val="FF9300"/>
    <a:srgbClr val="00FDFF"/>
    <a:srgbClr val="AB7942"/>
    <a:srgbClr val="0432FF"/>
    <a:srgbClr val="000000"/>
    <a:srgbClr val="FF230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845"/>
    <p:restoredTop sz="94654"/>
  </p:normalViewPr>
  <p:slideViewPr>
    <p:cSldViewPr snapToGrid="0" snapToObjects="1">
      <p:cViewPr varScale="1">
        <p:scale>
          <a:sx n="80" d="100"/>
          <a:sy n="80" d="100"/>
        </p:scale>
        <p:origin x="2952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C755E8DA-D140-4525-B90F-A53BC84B6658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15C22E02-356F-4B1C-959B-387D6D3F137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7818869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2FB0DD9D-3FE9-4C1C-A585-AA80E61305A3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952EA676-B89B-4AC9-A010-36407440C4F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3902844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78FBE9-40FF-431E-BB0C-34EB3F15C1A9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A07166-7FF9-4476-AA05-06776DBE999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653ED1-8A45-44C5-869F-F75C6AECB4D5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0A3DDE-4C8C-4986-86E1-431208CC286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69655A-3BBD-423A-9145-4798C0F9FA1F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2E1139-5FB3-4007-8FEC-C87B76386DF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27240C-9714-4CA8-B3A0-D28ED8F4383D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FA997F-0CDE-415B-8E86-E87E95F3594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BF8E30-90C7-4746-B88A-00E58B9371D0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EFC3D3-FF9B-49D8-B53C-AAC6EC8F225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5ACD4C-8E7E-4456-8E0A-5A8DCC95E80D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E89445-3CE5-4D2F-9033-10C0DC9C5FC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A6AB00-8F55-40AB-9502-AD8A04869334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014BB0-2DE5-4257-AF53-0B464E37787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72C4FF-EB11-4ABF-A0BF-A53CD98E00BE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515099-CD54-4FD7-8473-C7D77269EAE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0FF9B2-B0BA-4CBB-9773-CC8548C895A8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8E0C80-D663-4416-AB6B-76D03A7C6B3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50D378-C994-4E26-8FFF-A08F12BA8587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7DC453-C50E-4D9B-A13B-7456DAF3CAC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38B739-1C2D-4646-A45D-64E58541AFD1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B5674D-B689-4383-9FEF-4019B968709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B8A255A1-CB23-4A5E-9766-2EB0AF3D2996}" type="datetimeFigureOut">
              <a:rPr lang="ja-JP" altLang="en-US"/>
              <a:pPr>
                <a:defRPr/>
              </a:pPr>
              <a:t>2024/12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CB5C0515-51D8-464D-AF20-B96D97742F8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F0852B-6AF5-3B2B-0C92-34BF57C8A44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2C9D6E9-E5CC-633E-E5C6-B6E3CD78DB9F}"/>
              </a:ext>
            </a:extLst>
          </p:cNvPr>
          <p:cNvSpPr txBox="1"/>
          <p:nvPr/>
        </p:nvSpPr>
        <p:spPr>
          <a:xfrm>
            <a:off x="207000" y="8502454"/>
            <a:ext cx="6444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he score of AI responses regarding age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.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A) Question 1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B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2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C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3,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(D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4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E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5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F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6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G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7,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(H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8. Kruskal-Wallis test was used for comparisons, *</a:t>
            </a:r>
            <a:r>
              <a:rPr lang="en-US" altLang="ja-JP" sz="1000" i="1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&lt;0.05. </a:t>
            </a:r>
            <a:r>
              <a:rPr lang="en-GB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Bars indicate mean and S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D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. 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897730D-6230-919E-D4CF-BC6AFF9A9DE4}"/>
              </a:ext>
            </a:extLst>
          </p:cNvPr>
          <p:cNvSpPr txBox="1"/>
          <p:nvPr/>
        </p:nvSpPr>
        <p:spPr>
          <a:xfrm>
            <a:off x="707348" y="24909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A</a:t>
            </a:r>
            <a:endParaRPr kumimoji="1" lang="ja-JP" altLang="en-US" sz="180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7907A78-EBFE-EF9E-85AE-C769A1BB57F4}"/>
              </a:ext>
            </a:extLst>
          </p:cNvPr>
          <p:cNvSpPr txBox="1"/>
          <p:nvPr/>
        </p:nvSpPr>
        <p:spPr>
          <a:xfrm>
            <a:off x="3336903" y="24909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B</a:t>
            </a:r>
            <a:endParaRPr kumimoji="1" lang="ja-JP" altLang="en-US" sz="180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917F758-5B72-8536-BFF3-54D3F40A748C}"/>
              </a:ext>
            </a:extLst>
          </p:cNvPr>
          <p:cNvSpPr txBox="1"/>
          <p:nvPr/>
        </p:nvSpPr>
        <p:spPr>
          <a:xfrm>
            <a:off x="707348" y="237852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C</a:t>
            </a:r>
            <a:endParaRPr kumimoji="1" lang="ja-JP" altLang="en-US" sz="180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4E71DDA-AFC8-D2EF-48F5-E3FE82DCAEE4}"/>
              </a:ext>
            </a:extLst>
          </p:cNvPr>
          <p:cNvSpPr txBox="1"/>
          <p:nvPr/>
        </p:nvSpPr>
        <p:spPr>
          <a:xfrm>
            <a:off x="3336903" y="237852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D</a:t>
            </a:r>
            <a:endParaRPr kumimoji="1" lang="ja-JP" altLang="en-US" sz="18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5ECD371-6240-E73B-C75F-36510B776EEA}"/>
              </a:ext>
            </a:extLst>
          </p:cNvPr>
          <p:cNvSpPr txBox="1"/>
          <p:nvPr/>
        </p:nvSpPr>
        <p:spPr>
          <a:xfrm>
            <a:off x="707348" y="429192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E</a:t>
            </a:r>
            <a:endParaRPr kumimoji="1" lang="ja-JP" altLang="en-US" sz="180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ABE95BB-3E30-5B11-55BE-FE3A13FB73B8}"/>
              </a:ext>
            </a:extLst>
          </p:cNvPr>
          <p:cNvSpPr txBox="1"/>
          <p:nvPr/>
        </p:nvSpPr>
        <p:spPr>
          <a:xfrm>
            <a:off x="3336903" y="429192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F</a:t>
            </a:r>
            <a:endParaRPr kumimoji="1" lang="ja-JP" altLang="en-US" sz="180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D29C9FB-871A-84B2-75D3-A29C281C9725}"/>
              </a:ext>
            </a:extLst>
          </p:cNvPr>
          <p:cNvSpPr txBox="1"/>
          <p:nvPr/>
        </p:nvSpPr>
        <p:spPr>
          <a:xfrm>
            <a:off x="707348" y="6205054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G</a:t>
            </a:r>
            <a:endParaRPr kumimoji="1" lang="ja-JP" altLang="en-US" sz="18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6F2ECE1-EB14-5695-7EDA-1F7BFE7E39F3}"/>
              </a:ext>
            </a:extLst>
          </p:cNvPr>
          <p:cNvSpPr txBox="1"/>
          <p:nvPr/>
        </p:nvSpPr>
        <p:spPr>
          <a:xfrm>
            <a:off x="3336903" y="620505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H</a:t>
            </a:r>
            <a:endParaRPr kumimoji="1" lang="ja-JP" altLang="en-US" sz="1800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5F269A4A-178A-F890-3A70-2CBA8D68BC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9869" y="400816"/>
            <a:ext cx="2520000" cy="1871138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54945811-CBBE-402D-E7FC-F498DF2C0A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1996" y="657343"/>
            <a:ext cx="2520000" cy="1614611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CD589954-C089-C386-37EC-D73A74A37F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9869" y="2576888"/>
            <a:ext cx="2520000" cy="1614611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508F887D-9CFA-C5A4-A12D-7F47A6EAE0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1996" y="2576888"/>
            <a:ext cx="2520000" cy="1614611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93F021F2-9AD0-E133-2D35-FAEBFABC95C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49869" y="4496433"/>
            <a:ext cx="2520000" cy="1614611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F57F54B6-CE11-C17D-1B48-C9D9EE10CAE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51996" y="4496433"/>
            <a:ext cx="2520000" cy="1614611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7D84AD1D-A91D-2FDE-CB8B-CA2D1CB0CD5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49869" y="6415977"/>
            <a:ext cx="2520000" cy="1614611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9D4AD57B-50A5-005B-9791-9F6C3BAC67A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51996" y="6415977"/>
            <a:ext cx="2520000" cy="16146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1193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/>
          <p:cNvSpPr txBox="1"/>
          <p:nvPr/>
        </p:nvSpPr>
        <p:spPr>
          <a:xfrm>
            <a:off x="207000" y="8502454"/>
            <a:ext cx="6444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2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he score of AI responses regarding dental abnormalities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.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A) Question 9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B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10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C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11,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(D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12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E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13. Kruskal-Wallis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was used for comparisons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*</a:t>
            </a:r>
            <a:r>
              <a:rPr lang="en-US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&lt;0.05,  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**</a:t>
            </a:r>
            <a:r>
              <a:rPr lang="en-US" altLang="ja-JP" sz="1000" i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&lt;0.01. 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Bars indicate mean and S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D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. 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AF415F9-28CB-64D8-5FDC-E04F08A8B5EA}"/>
              </a:ext>
            </a:extLst>
          </p:cNvPr>
          <p:cNvSpPr txBox="1"/>
          <p:nvPr/>
        </p:nvSpPr>
        <p:spPr>
          <a:xfrm>
            <a:off x="707348" y="91766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A</a:t>
            </a:r>
            <a:endParaRPr kumimoji="1" lang="ja-JP" altLang="en-US" sz="18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30244AF-DE92-DC41-8BA4-A5561F9C5B77}"/>
              </a:ext>
            </a:extLst>
          </p:cNvPr>
          <p:cNvSpPr txBox="1"/>
          <p:nvPr/>
        </p:nvSpPr>
        <p:spPr>
          <a:xfrm>
            <a:off x="3336903" y="91766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B</a:t>
            </a:r>
            <a:endParaRPr kumimoji="1" lang="ja-JP" altLang="en-US" sz="18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11E7866-58F8-C4F6-D96A-5A4CF1E900CA}"/>
              </a:ext>
            </a:extLst>
          </p:cNvPr>
          <p:cNvSpPr txBox="1"/>
          <p:nvPr/>
        </p:nvSpPr>
        <p:spPr>
          <a:xfrm>
            <a:off x="707348" y="318475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C</a:t>
            </a:r>
            <a:endParaRPr kumimoji="1" lang="ja-JP" altLang="en-US" sz="180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F15C22A-E1AE-F339-1AA1-D033F67B3220}"/>
              </a:ext>
            </a:extLst>
          </p:cNvPr>
          <p:cNvSpPr txBox="1"/>
          <p:nvPr/>
        </p:nvSpPr>
        <p:spPr>
          <a:xfrm>
            <a:off x="3336903" y="318475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D</a:t>
            </a:r>
            <a:endParaRPr kumimoji="1" lang="ja-JP" altLang="en-US" sz="180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5AEC259-8938-0930-0872-301706886140}"/>
              </a:ext>
            </a:extLst>
          </p:cNvPr>
          <p:cNvSpPr txBox="1"/>
          <p:nvPr/>
        </p:nvSpPr>
        <p:spPr>
          <a:xfrm>
            <a:off x="707348" y="509815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E</a:t>
            </a:r>
            <a:endParaRPr kumimoji="1" lang="ja-JP" altLang="en-US" sz="180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DFF7FD71-1605-F56A-A018-2E00A9AEE2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8328" y="1291229"/>
            <a:ext cx="2520000" cy="1788144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637D0DCE-D03C-15D4-FB69-1441A990A9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61735" y="1087517"/>
            <a:ext cx="2520000" cy="1991856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204C9FF8-9005-88B4-8000-6509945D16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8328" y="3389759"/>
            <a:ext cx="2520000" cy="1614611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05196BCA-0478-AB7D-79E4-EFC91B485F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61735" y="3389759"/>
            <a:ext cx="2520000" cy="1614611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D12D1F8-7EFC-6CB6-5090-FCF751ACC75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48328" y="5302132"/>
            <a:ext cx="2520000" cy="16146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54203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/>
          <p:cNvSpPr txBox="1"/>
          <p:nvPr/>
        </p:nvSpPr>
        <p:spPr>
          <a:xfrm>
            <a:off x="207000" y="8502454"/>
            <a:ext cx="6444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3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he score of AI responses regarding systemic diseases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.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A) Question 14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B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15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C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16,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(D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17. Kruskal-Wallis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was used for comparisons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*</a:t>
            </a:r>
            <a:r>
              <a:rPr lang="en-US" altLang="ja-JP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&lt;0.05,  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**</a:t>
            </a:r>
            <a:r>
              <a:rPr lang="en-US" altLang="ja-JP" sz="1000" i="1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&lt;0.01.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Bars indicate mean and S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D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. 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3238E1E-39D5-798E-AC8D-7AC119C658BC}"/>
              </a:ext>
            </a:extLst>
          </p:cNvPr>
          <p:cNvSpPr txBox="1"/>
          <p:nvPr/>
        </p:nvSpPr>
        <p:spPr>
          <a:xfrm>
            <a:off x="707348" y="149315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A</a:t>
            </a:r>
            <a:endParaRPr kumimoji="1" lang="ja-JP" altLang="en-US" sz="18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9856497-FC19-B6FE-C719-EA4A015E602A}"/>
              </a:ext>
            </a:extLst>
          </p:cNvPr>
          <p:cNvSpPr txBox="1"/>
          <p:nvPr/>
        </p:nvSpPr>
        <p:spPr>
          <a:xfrm>
            <a:off x="3336903" y="149315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B</a:t>
            </a:r>
            <a:endParaRPr kumimoji="1" lang="ja-JP" altLang="en-US" sz="180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321559E-B81B-039E-3573-D3E17B6DBA79}"/>
              </a:ext>
            </a:extLst>
          </p:cNvPr>
          <p:cNvSpPr txBox="1"/>
          <p:nvPr/>
        </p:nvSpPr>
        <p:spPr>
          <a:xfrm>
            <a:off x="707348" y="36013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C</a:t>
            </a:r>
            <a:endParaRPr kumimoji="1" lang="ja-JP" altLang="en-US" sz="18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5704833-783B-CFDE-56EC-D9EC4872B4BF}"/>
              </a:ext>
            </a:extLst>
          </p:cNvPr>
          <p:cNvSpPr txBox="1"/>
          <p:nvPr/>
        </p:nvSpPr>
        <p:spPr>
          <a:xfrm>
            <a:off x="3336903" y="36013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D</a:t>
            </a:r>
            <a:endParaRPr kumimoji="1" lang="ja-JP" altLang="en-US" sz="180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CF0FCE34-B8E6-75D6-5746-18E5EE457B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7963" y="1899413"/>
            <a:ext cx="2520000" cy="1614611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889B77B4-EF43-EFEA-8E38-C076005E21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7344" y="1642886"/>
            <a:ext cx="2520000" cy="187113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20502312-B70B-55B8-87BA-D9B82E1F15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7963" y="3738958"/>
            <a:ext cx="2520000" cy="205976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C02F5037-DF1E-FEDD-5FE0-65657698B5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7344" y="4184107"/>
            <a:ext cx="2520000" cy="16146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94231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/>
          <p:cNvSpPr txBox="1"/>
          <p:nvPr/>
        </p:nvSpPr>
        <p:spPr>
          <a:xfrm>
            <a:off x="207000" y="8502454"/>
            <a:ext cx="644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4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he score of AI responses regarding consultations from guardians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.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A) Question 18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B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19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C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Question 20. Kruskal-Wallis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was used for comparisons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.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GB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Bars indicate mean and S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D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. 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F1ECD74-F300-7CF9-3A58-B248E20D5826}"/>
              </a:ext>
            </a:extLst>
          </p:cNvPr>
          <p:cNvSpPr txBox="1"/>
          <p:nvPr/>
        </p:nvSpPr>
        <p:spPr>
          <a:xfrm>
            <a:off x="1966130" y="119574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A</a:t>
            </a:r>
            <a:endParaRPr kumimoji="1" lang="ja-JP" altLang="en-US" sz="18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C719CAE-55F8-C092-662D-8072E8B9E1B2}"/>
              </a:ext>
            </a:extLst>
          </p:cNvPr>
          <p:cNvSpPr txBox="1"/>
          <p:nvPr/>
        </p:nvSpPr>
        <p:spPr>
          <a:xfrm>
            <a:off x="1966130" y="316092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B</a:t>
            </a:r>
            <a:endParaRPr kumimoji="1" lang="ja-JP" altLang="en-US" sz="180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10F4C06-974B-364B-69DD-8FB483CBB0B7}"/>
              </a:ext>
            </a:extLst>
          </p:cNvPr>
          <p:cNvSpPr txBox="1"/>
          <p:nvPr/>
        </p:nvSpPr>
        <p:spPr>
          <a:xfrm>
            <a:off x="1966130" y="50622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C</a:t>
            </a:r>
            <a:endParaRPr kumimoji="1" lang="ja-JP" altLang="en-US" sz="180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45FBE446-DC1F-4AA3-CF30-C84D185FB3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5540" y="1442829"/>
            <a:ext cx="2520000" cy="1614611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52D15B8D-3230-CCEB-E89A-6506211F0A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65540" y="3361940"/>
            <a:ext cx="2520000" cy="1614611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997B09A-FE8B-C38E-D231-B1FE61DFF8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5540" y="5270365"/>
            <a:ext cx="2520000" cy="16146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04293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B4A62F7-416E-FA9A-C36A-1802BC44E811}"/>
              </a:ext>
            </a:extLst>
          </p:cNvPr>
          <p:cNvSpPr txBox="1"/>
          <p:nvPr/>
        </p:nvSpPr>
        <p:spPr>
          <a:xfrm>
            <a:off x="207000" y="8502454"/>
            <a:ext cx="644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5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creenshots of representative responses from each AI tool (accessed on 26 November 2024).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A)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ChatGPT 3,5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B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Microsoft Copilot, </a:t>
            </a:r>
            <a:r>
              <a:rPr lang="en-US" altLang="ja-JP" sz="1000" dirty="0"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C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) Gemini. 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 descr="グラフィカル ユーザー インターフェイス, テキスト, アプリケーション, メール&#10;&#10;自動的に生成された説明">
            <a:extLst>
              <a:ext uri="{FF2B5EF4-FFF2-40B4-BE49-F238E27FC236}">
                <a16:creationId xmlns:a16="http://schemas.microsoft.com/office/drawing/2014/main" id="{1C55B0AB-8E1E-DAF9-787C-5434A1BDA91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" r="-3699"/>
          <a:stretch/>
        </p:blipFill>
        <p:spPr>
          <a:xfrm>
            <a:off x="1911135" y="1186657"/>
            <a:ext cx="3034767" cy="1771624"/>
          </a:xfrm>
          <a:prstGeom prst="rect">
            <a:avLst/>
          </a:prstGeom>
          <a:effectLst/>
        </p:spPr>
      </p:pic>
      <p:pic>
        <p:nvPicPr>
          <p:cNvPr id="12" name="図 11" descr="グラフィカル ユーザー インターフェイス, テキスト, アプリケーション&#10;&#10;自動的に生成された説明">
            <a:extLst>
              <a:ext uri="{FF2B5EF4-FFF2-40B4-BE49-F238E27FC236}">
                <a16:creationId xmlns:a16="http://schemas.microsoft.com/office/drawing/2014/main" id="{544BD227-A1DC-9D67-9EF4-E84FD2646BF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7405" b="3423"/>
          <a:stretch/>
        </p:blipFill>
        <p:spPr>
          <a:xfrm>
            <a:off x="1911375" y="3210594"/>
            <a:ext cx="3034527" cy="1771624"/>
          </a:xfrm>
          <a:prstGeom prst="rect">
            <a:avLst/>
          </a:prstGeom>
        </p:spPr>
      </p:pic>
      <p:pic>
        <p:nvPicPr>
          <p:cNvPr id="14" name="図 13" descr="グラフィカル ユーザー インターフェイス, テキスト, アプリケーション, メール&#10;&#10;自動的に生成された説明">
            <a:extLst>
              <a:ext uri="{FF2B5EF4-FFF2-40B4-BE49-F238E27FC236}">
                <a16:creationId xmlns:a16="http://schemas.microsoft.com/office/drawing/2014/main" id="{15F19ED7-9AE5-0E54-255C-AC6EC2D6F768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30"/>
          <a:stretch/>
        </p:blipFill>
        <p:spPr>
          <a:xfrm>
            <a:off x="1911376" y="5234531"/>
            <a:ext cx="3034527" cy="1777773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F72417B-A222-BEA2-2ECB-89E9B1BE1E81}"/>
              </a:ext>
            </a:extLst>
          </p:cNvPr>
          <p:cNvSpPr txBox="1"/>
          <p:nvPr/>
        </p:nvSpPr>
        <p:spPr>
          <a:xfrm>
            <a:off x="1563493" y="118665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/>
              <a:t>A</a:t>
            </a:r>
            <a:endParaRPr kumimoji="1" lang="ja-JP" altLang="en-US" sz="18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BC2EE6B-AE04-DA7E-0F8F-8EAAE1208633}"/>
              </a:ext>
            </a:extLst>
          </p:cNvPr>
          <p:cNvSpPr txBox="1"/>
          <p:nvPr/>
        </p:nvSpPr>
        <p:spPr>
          <a:xfrm>
            <a:off x="1563493" y="32112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/>
              <a:t>B</a:t>
            </a:r>
            <a:endParaRPr kumimoji="1" lang="ja-JP" altLang="en-US" sz="18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6E913D3-5AFB-808A-D14A-EF4699E650A5}"/>
              </a:ext>
            </a:extLst>
          </p:cNvPr>
          <p:cNvSpPr txBox="1"/>
          <p:nvPr/>
        </p:nvSpPr>
        <p:spPr>
          <a:xfrm>
            <a:off x="1563493" y="523453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/>
              <a:t>C</a:t>
            </a:r>
            <a:endParaRPr kumimoji="1" lang="ja-JP" altLang="en-US" sz="1800" dirty="0"/>
          </a:p>
        </p:txBody>
      </p:sp>
    </p:spTree>
    <p:extLst>
      <p:ext uri="{BB962C8B-B14F-4D97-AF65-F5344CB8AC3E}">
        <p14:creationId xmlns:p14="http://schemas.microsoft.com/office/powerpoint/2010/main" val="78710758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08</TotalTime>
  <Words>309</Words>
  <Application>Microsoft Office PowerPoint</Application>
  <PresentationFormat>On-screen Show (4:3)</PresentationFormat>
  <Paragraphs>2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ホワイト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edomacmini11</dc:creator>
  <cp:lastModifiedBy>MDPI</cp:lastModifiedBy>
  <cp:revision>1442</cp:revision>
  <cp:lastPrinted>2022-12-21T02:51:10Z</cp:lastPrinted>
  <dcterms:created xsi:type="dcterms:W3CDTF">2013-03-23T13:44:46Z</dcterms:created>
  <dcterms:modified xsi:type="dcterms:W3CDTF">2024-12-14T10:03:42Z</dcterms:modified>
</cp:coreProperties>
</file>